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sldIdLst>
    <p:sldId id="264" r:id="rId2"/>
  </p:sldIdLst>
  <p:sldSz cx="5400675" cy="4319588"/>
  <p:notesSz cx="6858000" cy="9144000"/>
  <p:defaultTextStyle>
    <a:defPPr>
      <a:defRPr lang="ja-JP"/>
    </a:defPPr>
    <a:lvl1pPr marL="0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1pPr>
    <a:lvl2pPr marL="301813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2pPr>
    <a:lvl3pPr marL="603625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3pPr>
    <a:lvl4pPr marL="905439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4pPr>
    <a:lvl5pPr marL="1207252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5pPr>
    <a:lvl6pPr marL="1509065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6pPr>
    <a:lvl7pPr marL="1810876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7pPr>
    <a:lvl8pPr marL="2112692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8pPr>
    <a:lvl9pPr marL="2414505" algn="l" defTabSz="603625" rtl="0" eaLnBrk="1" latinLnBrk="0" hangingPunct="1">
      <a:defRPr kumimoji="1" sz="118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1" userDrawn="1">
          <p15:clr>
            <a:srgbClr val="A4A3A4"/>
          </p15:clr>
        </p15:guide>
        <p15:guide id="2" pos="17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02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468" y="364"/>
      </p:cViewPr>
      <p:guideLst>
        <p:guide orient="horz" pos="1361"/>
        <p:guide pos="17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706933"/>
            <a:ext cx="4590574" cy="1503857"/>
          </a:xfrm>
        </p:spPr>
        <p:txBody>
          <a:bodyPr anchor="b"/>
          <a:lstStyle>
            <a:lvl1pPr algn="ctr">
              <a:defRPr sz="354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2268784"/>
            <a:ext cx="4050506" cy="1042900"/>
          </a:xfrm>
        </p:spPr>
        <p:txBody>
          <a:bodyPr/>
          <a:lstStyle>
            <a:lvl1pPr marL="0" indent="0" algn="ctr">
              <a:buNone/>
              <a:defRPr sz="1417"/>
            </a:lvl1pPr>
            <a:lvl2pPr marL="270022" indent="0" algn="ctr">
              <a:buNone/>
              <a:defRPr sz="1181"/>
            </a:lvl2pPr>
            <a:lvl3pPr marL="540045" indent="0" algn="ctr">
              <a:buNone/>
              <a:defRPr sz="1063"/>
            </a:lvl3pPr>
            <a:lvl4pPr marL="810067" indent="0" algn="ctr">
              <a:buNone/>
              <a:defRPr sz="945"/>
            </a:lvl4pPr>
            <a:lvl5pPr marL="1080089" indent="0" algn="ctr">
              <a:buNone/>
              <a:defRPr sz="945"/>
            </a:lvl5pPr>
            <a:lvl6pPr marL="1350112" indent="0" algn="ctr">
              <a:buNone/>
              <a:defRPr sz="945"/>
            </a:lvl6pPr>
            <a:lvl7pPr marL="1620134" indent="0" algn="ctr">
              <a:buNone/>
              <a:defRPr sz="945"/>
            </a:lvl7pPr>
            <a:lvl8pPr marL="1890156" indent="0" algn="ctr">
              <a:buNone/>
              <a:defRPr sz="945"/>
            </a:lvl8pPr>
            <a:lvl9pPr marL="2160179" indent="0" algn="ctr">
              <a:buNone/>
              <a:defRPr sz="945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641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4209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229978"/>
            <a:ext cx="1164521" cy="3660651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229978"/>
            <a:ext cx="3426053" cy="3660651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009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273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1076899"/>
            <a:ext cx="4658082" cy="1796828"/>
          </a:xfrm>
        </p:spPr>
        <p:txBody>
          <a:bodyPr anchor="b"/>
          <a:lstStyle>
            <a:lvl1pPr>
              <a:defRPr sz="354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2890725"/>
            <a:ext cx="4658082" cy="944910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/>
                </a:solidFill>
              </a:defRPr>
            </a:lvl1pPr>
            <a:lvl2pPr marL="270022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40045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10067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8008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50112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20134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9015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6017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592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1149890"/>
            <a:ext cx="2295287" cy="274073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1149890"/>
            <a:ext cx="2295287" cy="274073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374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29979"/>
            <a:ext cx="4658082" cy="834921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1058899"/>
            <a:ext cx="2284738" cy="518950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1577849"/>
            <a:ext cx="2284738" cy="232077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1058899"/>
            <a:ext cx="2295990" cy="518950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1577849"/>
            <a:ext cx="2295990" cy="232077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009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640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0960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87972"/>
            <a:ext cx="1741858" cy="1007904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621942"/>
            <a:ext cx="2734092" cy="3069707"/>
          </a:xfrm>
        </p:spPr>
        <p:txBody>
          <a:bodyPr/>
          <a:lstStyle>
            <a:lvl1pPr>
              <a:defRPr sz="1890"/>
            </a:lvl1pPr>
            <a:lvl2pPr>
              <a:defRPr sz="1654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295877"/>
            <a:ext cx="1741858" cy="2400771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976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87972"/>
            <a:ext cx="1741858" cy="1007904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621942"/>
            <a:ext cx="2734092" cy="3069707"/>
          </a:xfrm>
        </p:spPr>
        <p:txBody>
          <a:bodyPr anchor="t"/>
          <a:lstStyle>
            <a:lvl1pPr marL="0" indent="0">
              <a:buNone/>
              <a:defRPr sz="1890"/>
            </a:lvl1pPr>
            <a:lvl2pPr marL="270022" indent="0">
              <a:buNone/>
              <a:defRPr sz="1654"/>
            </a:lvl2pPr>
            <a:lvl3pPr marL="540045" indent="0">
              <a:buNone/>
              <a:defRPr sz="1417"/>
            </a:lvl3pPr>
            <a:lvl4pPr marL="810067" indent="0">
              <a:buNone/>
              <a:defRPr sz="1181"/>
            </a:lvl4pPr>
            <a:lvl5pPr marL="1080089" indent="0">
              <a:buNone/>
              <a:defRPr sz="1181"/>
            </a:lvl5pPr>
            <a:lvl6pPr marL="1350112" indent="0">
              <a:buNone/>
              <a:defRPr sz="1181"/>
            </a:lvl6pPr>
            <a:lvl7pPr marL="1620134" indent="0">
              <a:buNone/>
              <a:defRPr sz="1181"/>
            </a:lvl7pPr>
            <a:lvl8pPr marL="1890156" indent="0">
              <a:buNone/>
              <a:defRPr sz="1181"/>
            </a:lvl8pPr>
            <a:lvl9pPr marL="2160179" indent="0">
              <a:buNone/>
              <a:defRPr sz="1181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295877"/>
            <a:ext cx="1741858" cy="2400771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1584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229979"/>
            <a:ext cx="4658082" cy="834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1149890"/>
            <a:ext cx="4658082" cy="27407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4003619"/>
            <a:ext cx="1215152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5E53B-7A35-465D-8A73-8B10DAAAF9FC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4003619"/>
            <a:ext cx="1822728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4003619"/>
            <a:ext cx="1215152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6FB5B3-1F71-412A-8A00-9BD8D2F54B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310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540045" rtl="0" eaLnBrk="1" latinLnBrk="0" hangingPunct="1">
        <a:lnSpc>
          <a:spcPct val="90000"/>
        </a:lnSpc>
        <a:spcBef>
          <a:spcPct val="0"/>
        </a:spcBef>
        <a:buNone/>
        <a:defRPr kumimoji="1" sz="2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5011" indent="-135011" algn="l" defTabSz="540045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0503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5056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5078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510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512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5145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5167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519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7002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40045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10067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8008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5011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20134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90156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6017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370" y="595072"/>
            <a:ext cx="2257200" cy="151392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4570" y="595072"/>
            <a:ext cx="2257200" cy="151392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2520" y="2271650"/>
            <a:ext cx="2257200" cy="151392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テキスト ボックス 4"/>
          <p:cNvSpPr txBox="1"/>
          <p:nvPr/>
        </p:nvSpPr>
        <p:spPr>
          <a:xfrm rot="16200000">
            <a:off x="148733" y="1142569"/>
            <a:ext cx="9509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Cumulative survival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443182" y="1137583"/>
            <a:ext cx="5325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i="1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 &lt;0.001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499924" y="1932233"/>
            <a:ext cx="37382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Days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303005" y="2119913"/>
            <a:ext cx="975265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H</a:t>
            </a:r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andgrip </a:t>
            </a:r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strength</a:t>
            </a:r>
            <a:endParaRPr lang="ja-JP" altLang="en-US" sz="8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1024726" y="452377"/>
            <a:ext cx="1399256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Quadriceps </a:t>
            </a:r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muscle </a:t>
            </a:r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thickness</a:t>
            </a:r>
            <a:endParaRPr lang="ja-JP" altLang="en-US" sz="8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3388702" y="452377"/>
            <a:ext cx="107437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T</a:t>
            </a:r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high circumference</a:t>
            </a:r>
            <a:endParaRPr lang="ja-JP" altLang="en-US" sz="8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2399692" y="1131557"/>
            <a:ext cx="9509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Cumulative survival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673425" y="1131558"/>
            <a:ext cx="58596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i="1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 &lt;0.001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746095" y="1926208"/>
            <a:ext cx="4113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Days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1226343" y="2765465"/>
            <a:ext cx="9509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Cumulative survival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538744" y="2790866"/>
            <a:ext cx="5325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i="1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 &lt;0.001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595486" y="3585516"/>
            <a:ext cx="37382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>
                <a:latin typeface="Segoe UI" panose="020B0502040204020203" pitchFamily="34" charset="0"/>
                <a:cs typeface="Segoe UI" panose="020B0502040204020203" pitchFamily="34" charset="0"/>
              </a:rPr>
              <a:t>Days</a:t>
            </a:r>
            <a:endParaRPr lang="ja-JP" altLang="en-US" sz="7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45962" y="23297"/>
            <a:ext cx="5317216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dditional Figure</a:t>
            </a:r>
            <a:r>
              <a:rPr lang="en-US" altLang="ja-JP" sz="10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Kaplan–Meier curves for fall injury in quadriceps muscle thickness, thigh circumference, and handgrip strength</a:t>
            </a:r>
            <a:endParaRPr lang="ja-JP" altLang="ja-JP" sz="10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45962" y="3743585"/>
            <a:ext cx="531721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Caption] Fall injuries in patients with quadriceps muscle thickness or thigh circumference below the cutoff values were observed earlier within a 60-day period, and these findings were not observed in patients with handgrip strength below the cutoff values.</a:t>
            </a:r>
            <a:endParaRPr lang="ja-JP" altLang="ja-JP" sz="9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5180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</TotalTime>
  <Words>86</Words>
  <Application>Microsoft Office PowerPoint</Application>
  <PresentationFormat>ユーザー設定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游ゴシック</vt:lpstr>
      <vt:lpstr>游ゴシック Light</vt:lpstr>
      <vt:lpstr>游明朝</vt:lpstr>
      <vt:lpstr>Arial</vt:lpstr>
      <vt:lpstr>Calibri</vt:lpstr>
      <vt:lpstr>Calibri Light</vt:lpstr>
      <vt:lpstr>Segoe UI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HASHI YASUSHI</dc:creator>
  <cp:lastModifiedBy>OHASHI YASUSHI</cp:lastModifiedBy>
  <cp:revision>30</cp:revision>
  <cp:lastPrinted>2020-12-29T05:12:58Z</cp:lastPrinted>
  <dcterms:created xsi:type="dcterms:W3CDTF">2020-06-27T10:21:12Z</dcterms:created>
  <dcterms:modified xsi:type="dcterms:W3CDTF">2021-04-15T12:08:29Z</dcterms:modified>
</cp:coreProperties>
</file>